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61" r:id="rId2"/>
    <p:sldId id="272" r:id="rId3"/>
    <p:sldId id="273" r:id="rId4"/>
    <p:sldId id="274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448" autoAdjust="0"/>
    <p:restoredTop sz="94220" autoAdjust="0"/>
  </p:normalViewPr>
  <p:slideViewPr>
    <p:cSldViewPr snapToGrid="0">
      <p:cViewPr varScale="1">
        <p:scale>
          <a:sx n="104" d="100"/>
          <a:sy n="104" d="100"/>
        </p:scale>
        <p:origin x="6906" y="13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25766-C0FB-4FAD-AC56-C6577F1E0B5F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2EF1C2-FB5A-45B6-8E94-937912646E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38428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4093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062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9548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4049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1106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7712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4400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9018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4075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05533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9093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2451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677768EF-5FBE-42E1-BE44-D9973CAA4DFC}"/>
              </a:ext>
            </a:extLst>
          </p:cNvPr>
          <p:cNvSpPr txBox="1"/>
          <p:nvPr/>
        </p:nvSpPr>
        <p:spPr>
          <a:xfrm>
            <a:off x="2148458" y="452646"/>
            <a:ext cx="28119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evel 2 GO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erms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expression pattern Profile 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8DE0D72E-821E-4615-8874-C0AAC14CE683}"/>
              </a:ext>
            </a:extLst>
          </p:cNvPr>
          <p:cNvSpPr txBox="1"/>
          <p:nvPr/>
        </p:nvSpPr>
        <p:spPr>
          <a:xfrm>
            <a:off x="2148458" y="4638565"/>
            <a:ext cx="28119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evel 2 GO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erms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expression pattern Profile 8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3EC1B4E-2665-4E4F-8895-3C0C394F7E09}"/>
              </a:ext>
            </a:extLst>
          </p:cNvPr>
          <p:cNvSpPr txBox="1"/>
          <p:nvPr/>
        </p:nvSpPr>
        <p:spPr>
          <a:xfrm>
            <a:off x="786019" y="429563"/>
            <a:ext cx="2792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D4FE4DCB-0FE6-4770-90A7-D2B51E04992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16" r="4837"/>
          <a:stretch/>
        </p:blipFill>
        <p:spPr>
          <a:xfrm>
            <a:off x="327219" y="668090"/>
            <a:ext cx="6526299" cy="3730282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CC890393-5DD2-4E52-B801-1CC0AD00F7A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17" r="4837"/>
          <a:stretch/>
        </p:blipFill>
        <p:spPr>
          <a:xfrm>
            <a:off x="327219" y="4854009"/>
            <a:ext cx="6526299" cy="3730282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62A992AD-25A6-4E0D-AB91-A55D2E507208}"/>
              </a:ext>
            </a:extLst>
          </p:cNvPr>
          <p:cNvSpPr txBox="1"/>
          <p:nvPr/>
        </p:nvSpPr>
        <p:spPr>
          <a:xfrm>
            <a:off x="779924" y="4620855"/>
            <a:ext cx="2792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88168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677768EF-5FBE-42E1-BE44-D9973CAA4DFC}"/>
              </a:ext>
            </a:extLst>
          </p:cNvPr>
          <p:cNvSpPr txBox="1"/>
          <p:nvPr/>
        </p:nvSpPr>
        <p:spPr>
          <a:xfrm>
            <a:off x="2148458" y="452646"/>
            <a:ext cx="28696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evel 2 GO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erms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expression pattern Profile 1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8DE0D72E-821E-4615-8874-C0AAC14CE683}"/>
              </a:ext>
            </a:extLst>
          </p:cNvPr>
          <p:cNvSpPr txBox="1"/>
          <p:nvPr/>
        </p:nvSpPr>
        <p:spPr>
          <a:xfrm>
            <a:off x="2148458" y="4638565"/>
            <a:ext cx="28696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evel 2 GO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erms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expression pattern Profile 16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3EC1B4E-2665-4E4F-8895-3C0C394F7E09}"/>
              </a:ext>
            </a:extLst>
          </p:cNvPr>
          <p:cNvSpPr txBox="1"/>
          <p:nvPr/>
        </p:nvSpPr>
        <p:spPr>
          <a:xfrm>
            <a:off x="786019" y="429563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62A992AD-25A6-4E0D-AB91-A55D2E507208}"/>
              </a:ext>
            </a:extLst>
          </p:cNvPr>
          <p:cNvSpPr txBox="1"/>
          <p:nvPr/>
        </p:nvSpPr>
        <p:spPr>
          <a:xfrm>
            <a:off x="779924" y="4620855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40004166-DCE4-4943-8723-A66F84AC851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59" r="5555"/>
          <a:stretch/>
        </p:blipFill>
        <p:spPr>
          <a:xfrm>
            <a:off x="381000" y="4886567"/>
            <a:ext cx="6477000" cy="3720807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CDC8013E-24EE-45E9-89FD-25A21B78C71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16" r="5555"/>
          <a:stretch/>
        </p:blipFill>
        <p:spPr>
          <a:xfrm>
            <a:off x="381000" y="691173"/>
            <a:ext cx="6477000" cy="37302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64438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677768EF-5FBE-42E1-BE44-D9973CAA4DFC}"/>
              </a:ext>
            </a:extLst>
          </p:cNvPr>
          <p:cNvSpPr txBox="1"/>
          <p:nvPr/>
        </p:nvSpPr>
        <p:spPr>
          <a:xfrm>
            <a:off x="2148458" y="452646"/>
            <a:ext cx="28696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evel 2 GO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erms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expression pattern Profile 20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8DE0D72E-821E-4615-8874-C0AAC14CE683}"/>
              </a:ext>
            </a:extLst>
          </p:cNvPr>
          <p:cNvSpPr txBox="1"/>
          <p:nvPr/>
        </p:nvSpPr>
        <p:spPr>
          <a:xfrm>
            <a:off x="2148458" y="4638565"/>
            <a:ext cx="28696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evel 2 GO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erms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expression pattern Profile 23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3EC1B4E-2665-4E4F-8895-3C0C394F7E09}"/>
              </a:ext>
            </a:extLst>
          </p:cNvPr>
          <p:cNvSpPr txBox="1"/>
          <p:nvPr/>
        </p:nvSpPr>
        <p:spPr>
          <a:xfrm>
            <a:off x="786019" y="429563"/>
            <a:ext cx="2792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62A992AD-25A6-4E0D-AB91-A55D2E507208}"/>
              </a:ext>
            </a:extLst>
          </p:cNvPr>
          <p:cNvSpPr txBox="1"/>
          <p:nvPr/>
        </p:nvSpPr>
        <p:spPr>
          <a:xfrm>
            <a:off x="779924" y="4620855"/>
            <a:ext cx="2792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998470E9-D933-49FB-9282-C7FADCD5FDC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21" r="5555"/>
          <a:stretch/>
        </p:blipFill>
        <p:spPr>
          <a:xfrm>
            <a:off x="344806" y="693420"/>
            <a:ext cx="6477000" cy="3722333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7FF21B25-7E79-4401-A149-3AF0F02AC3A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18" r="5555"/>
          <a:stretch/>
        </p:blipFill>
        <p:spPr>
          <a:xfrm>
            <a:off x="190500" y="4864022"/>
            <a:ext cx="6477000" cy="37302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02417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677768EF-5FBE-42E1-BE44-D9973CAA4DFC}"/>
              </a:ext>
            </a:extLst>
          </p:cNvPr>
          <p:cNvSpPr txBox="1"/>
          <p:nvPr/>
        </p:nvSpPr>
        <p:spPr>
          <a:xfrm>
            <a:off x="2148458" y="452646"/>
            <a:ext cx="28696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Level 2 GO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erms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DEGs of expression pattern Profile 25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53EC1B4E-2665-4E4F-8895-3C0C394F7E09}"/>
              </a:ext>
            </a:extLst>
          </p:cNvPr>
          <p:cNvSpPr txBox="1"/>
          <p:nvPr/>
        </p:nvSpPr>
        <p:spPr>
          <a:xfrm>
            <a:off x="786019" y="429563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7781259-A638-4B45-919D-ED550206751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17" r="4837"/>
          <a:stretch/>
        </p:blipFill>
        <p:spPr>
          <a:xfrm>
            <a:off x="282555" y="691173"/>
            <a:ext cx="6526299" cy="3730282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F2D2132D-393C-4AB9-9C46-11FE8CBBDE85}"/>
              </a:ext>
            </a:extLst>
          </p:cNvPr>
          <p:cNvSpPr txBox="1"/>
          <p:nvPr/>
        </p:nvSpPr>
        <p:spPr>
          <a:xfrm>
            <a:off x="282555" y="4444538"/>
            <a:ext cx="652629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zh-CN" sz="1200" b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4. Gene Ontology (GO) term enrichment for DEGs belonging to significant gene clusters. (A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luster 0,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luster 8,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luster 13,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D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luster 16,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E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luster 20,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F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luster 23,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G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luster 25.</a:t>
            </a:r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93769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38</TotalTime>
  <Words>144</Words>
  <Application>Microsoft Office PowerPoint</Application>
  <PresentationFormat>A4 纸张(210x297 毫米)</PresentationFormat>
  <Paragraphs>15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 Tianyi</dc:creator>
  <cp:lastModifiedBy>Ma Tianyi</cp:lastModifiedBy>
  <cp:revision>129</cp:revision>
  <dcterms:created xsi:type="dcterms:W3CDTF">2021-01-19T12:49:28Z</dcterms:created>
  <dcterms:modified xsi:type="dcterms:W3CDTF">2023-01-10T11:16:38Z</dcterms:modified>
</cp:coreProperties>
</file>